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745"/>
    <p:restoredTop sz="94696"/>
  </p:normalViewPr>
  <p:slideViewPr>
    <p:cSldViewPr>
      <p:cViewPr varScale="1">
        <p:scale>
          <a:sx n="84" d="100"/>
          <a:sy n="84" d="100"/>
        </p:scale>
        <p:origin x="102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ampus.unibe.ch\vet-home\buers\Dokumente\Mbovis\writing\BoMac_Nina\171025%20growth%20curve%20spent%20BoMa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3400100781053E-2"/>
          <c:y val="0.12886485260771"/>
          <c:w val="0.667179642227261"/>
          <c:h val="0.711530612244898"/>
        </c:manualLayout>
      </c:layout>
      <c:lineChart>
        <c:grouping val="standard"/>
        <c:varyColors val="0"/>
        <c:ser>
          <c:idx val="1"/>
          <c:order val="1"/>
          <c:tx>
            <c:strRef>
              <c:f>triplicates!$N$2</c:f>
              <c:strCache>
                <c:ptCount val="1"/>
                <c:pt idx="0">
                  <c:v>MEM-Earle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N$11:$N$15</c:f>
                <c:numCache>
                  <c:formatCode>General</c:formatCode>
                  <c:ptCount val="5"/>
                  <c:pt idx="0">
                    <c:v>0.13254403107352</c:v>
                  </c:pt>
                  <c:pt idx="1">
                    <c:v>4.8729753608007603E-2</c:v>
                  </c:pt>
                  <c:pt idx="2">
                    <c:v>1.6180184734745601E-2</c:v>
                  </c:pt>
                  <c:pt idx="3">
                    <c:v>0.105911442109834</c:v>
                  </c:pt>
                  <c:pt idx="4">
                    <c:v>0</c:v>
                  </c:pt>
                </c:numCache>
              </c:numRef>
            </c:plus>
            <c:minus>
              <c:numRef>
                <c:f>triplicates!$N$11:$N$15</c:f>
                <c:numCache>
                  <c:formatCode>General</c:formatCode>
                  <c:ptCount val="5"/>
                  <c:pt idx="0">
                    <c:v>0.13254403107352</c:v>
                  </c:pt>
                  <c:pt idx="1">
                    <c:v>4.8729753608007603E-2</c:v>
                  </c:pt>
                  <c:pt idx="2">
                    <c:v>1.6180184734745601E-2</c:v>
                  </c:pt>
                  <c:pt idx="3">
                    <c:v>0.105911442109834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N$3:$N$7</c:f>
              <c:numCache>
                <c:formatCode>General</c:formatCode>
                <c:ptCount val="5"/>
                <c:pt idx="0">
                  <c:v>5.0309830563886164</c:v>
                </c:pt>
                <c:pt idx="1">
                  <c:v>4.9221826284541477</c:v>
                </c:pt>
                <c:pt idx="2">
                  <c:v>3.9049200287670449</c:v>
                </c:pt>
                <c:pt idx="3">
                  <c:v>2.1786061136905182</c:v>
                </c:pt>
                <c:pt idx="4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9FB-4FD9-A359-3B71D8CDC24C}"/>
            </c:ext>
          </c:extLst>
        </c:ser>
        <c:ser>
          <c:idx val="3"/>
          <c:order val="3"/>
          <c:tx>
            <c:strRef>
              <c:f>triplicates!$P$2</c:f>
              <c:strCache>
                <c:ptCount val="1"/>
                <c:pt idx="0">
                  <c:v>48 hours spent medium Bomac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5"/>
            <c:spPr>
              <a:noFill/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T$11:$T$15</c:f>
                <c:numCache>
                  <c:formatCode>General</c:formatCode>
                  <c:ptCount val="5"/>
                  <c:pt idx="0">
                    <c:v>2.44179209709698E-2</c:v>
                  </c:pt>
                  <c:pt idx="1">
                    <c:v>6.8961312633431596E-2</c:v>
                  </c:pt>
                  <c:pt idx="2">
                    <c:v>9.6964284828795107E-3</c:v>
                  </c:pt>
                  <c:pt idx="3">
                    <c:v>9.6271175490407201E-3</c:v>
                  </c:pt>
                  <c:pt idx="4">
                    <c:v>0.22652678162633699</c:v>
                  </c:pt>
                </c:numCache>
              </c:numRef>
            </c:plus>
            <c:minus>
              <c:numRef>
                <c:f>triplicates!$T$11:$T$15</c:f>
                <c:numCache>
                  <c:formatCode>General</c:formatCode>
                  <c:ptCount val="5"/>
                  <c:pt idx="0">
                    <c:v>2.44179209709698E-2</c:v>
                  </c:pt>
                  <c:pt idx="1">
                    <c:v>6.8961312633431596E-2</c:v>
                  </c:pt>
                  <c:pt idx="2">
                    <c:v>9.6964284828795107E-3</c:v>
                  </c:pt>
                  <c:pt idx="3">
                    <c:v>9.6271175490407201E-3</c:v>
                  </c:pt>
                  <c:pt idx="4">
                    <c:v>0.22652678162633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P$3:$P$7</c:f>
              <c:numCache>
                <c:formatCode>General</c:formatCode>
                <c:ptCount val="5"/>
                <c:pt idx="0">
                  <c:v>4.8586255927194273</c:v>
                </c:pt>
                <c:pt idx="1">
                  <c:v>5.5574536164809452</c:v>
                </c:pt>
                <c:pt idx="2">
                  <c:v>6.6287142490553892</c:v>
                </c:pt>
                <c:pt idx="3">
                  <c:v>6.311719342739269</c:v>
                </c:pt>
                <c:pt idx="4">
                  <c:v>4.81196750428928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9FB-4FD9-A359-3B71D8CDC24C}"/>
            </c:ext>
          </c:extLst>
        </c:ser>
        <c:ser>
          <c:idx val="5"/>
          <c:order val="5"/>
          <c:tx>
            <c:strRef>
              <c:f>triplicates!$R$2</c:f>
              <c:strCache>
                <c:ptCount val="1"/>
                <c:pt idx="0">
                  <c:v>24 hours spent medium Bomac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lg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R$11:$R$15</c:f>
                <c:numCache>
                  <c:formatCode>General</c:formatCode>
                  <c:ptCount val="5"/>
                  <c:pt idx="0">
                    <c:v>2.4956176138025699E-2</c:v>
                  </c:pt>
                  <c:pt idx="1">
                    <c:v>5.5472882717448602E-2</c:v>
                  </c:pt>
                  <c:pt idx="2">
                    <c:v>5.9743023153419797E-2</c:v>
                  </c:pt>
                  <c:pt idx="3">
                    <c:v>7.15421217863631E-2</c:v>
                  </c:pt>
                  <c:pt idx="4">
                    <c:v>0.40673929169054901</c:v>
                  </c:pt>
                </c:numCache>
              </c:numRef>
            </c:plus>
            <c:minus>
              <c:numRef>
                <c:f>triplicates!$R$11:$R$15</c:f>
                <c:numCache>
                  <c:formatCode>General</c:formatCode>
                  <c:ptCount val="5"/>
                  <c:pt idx="0">
                    <c:v>2.4956176138025699E-2</c:v>
                  </c:pt>
                  <c:pt idx="1">
                    <c:v>5.5472882717448602E-2</c:v>
                  </c:pt>
                  <c:pt idx="2">
                    <c:v>5.9743023153419797E-2</c:v>
                  </c:pt>
                  <c:pt idx="3">
                    <c:v>7.15421217863631E-2</c:v>
                  </c:pt>
                  <c:pt idx="4">
                    <c:v>0.406739291690549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R$3:$R$7</c:f>
              <c:numCache>
                <c:formatCode>General</c:formatCode>
                <c:ptCount val="5"/>
                <c:pt idx="0">
                  <c:v>5.0770687716470002</c:v>
                </c:pt>
                <c:pt idx="1">
                  <c:v>5.5595574413447704</c:v>
                </c:pt>
                <c:pt idx="2">
                  <c:v>6.7749657134145806</c:v>
                </c:pt>
                <c:pt idx="3">
                  <c:v>6.4570216815134964</c:v>
                </c:pt>
                <c:pt idx="4">
                  <c:v>5.14736113328843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9FB-4FD9-A359-3B71D8CDC24C}"/>
            </c:ext>
          </c:extLst>
        </c:ser>
        <c:ser>
          <c:idx val="7"/>
          <c:order val="7"/>
          <c:tx>
            <c:strRef>
              <c:f>triplicates!$T$2</c:f>
              <c:strCache>
                <c:ptCount val="1"/>
                <c:pt idx="0">
                  <c:v>48 hours spent medium Bomac + BVDV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T$11:$T$15</c:f>
                <c:numCache>
                  <c:formatCode>General</c:formatCode>
                  <c:ptCount val="5"/>
                  <c:pt idx="0">
                    <c:v>2.44179209709698E-2</c:v>
                  </c:pt>
                  <c:pt idx="1">
                    <c:v>6.8961312633431596E-2</c:v>
                  </c:pt>
                  <c:pt idx="2">
                    <c:v>9.6964284828795107E-3</c:v>
                  </c:pt>
                  <c:pt idx="3">
                    <c:v>9.6271175490407201E-3</c:v>
                  </c:pt>
                  <c:pt idx="4">
                    <c:v>0.22652678162633699</c:v>
                  </c:pt>
                </c:numCache>
              </c:numRef>
            </c:plus>
            <c:minus>
              <c:numRef>
                <c:f>triplicates!$T$11:$T$15</c:f>
                <c:numCache>
                  <c:formatCode>General</c:formatCode>
                  <c:ptCount val="5"/>
                  <c:pt idx="0">
                    <c:v>2.44179209709698E-2</c:v>
                  </c:pt>
                  <c:pt idx="1">
                    <c:v>6.8961312633431596E-2</c:v>
                  </c:pt>
                  <c:pt idx="2">
                    <c:v>9.6964284828795107E-3</c:v>
                  </c:pt>
                  <c:pt idx="3">
                    <c:v>9.6271175490407201E-3</c:v>
                  </c:pt>
                  <c:pt idx="4">
                    <c:v>0.22652678162633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T$3:$T$7</c:f>
              <c:numCache>
                <c:formatCode>General</c:formatCode>
                <c:ptCount val="5"/>
                <c:pt idx="0">
                  <c:v>5.1126127338325063</c:v>
                </c:pt>
                <c:pt idx="1">
                  <c:v>5.58329837346521</c:v>
                </c:pt>
                <c:pt idx="2">
                  <c:v>6.7393106005120771</c:v>
                </c:pt>
                <c:pt idx="3">
                  <c:v>6.3551938351039201</c:v>
                </c:pt>
                <c:pt idx="4">
                  <c:v>4.82183538708289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9FB-4FD9-A359-3B71D8CDC24C}"/>
            </c:ext>
          </c:extLst>
        </c:ser>
        <c:ser>
          <c:idx val="9"/>
          <c:order val="9"/>
          <c:tx>
            <c:strRef>
              <c:f>triplicates!$V$2</c:f>
              <c:strCache>
                <c:ptCount val="1"/>
                <c:pt idx="0">
                  <c:v>24 hours spent medium Bomac + BVDV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triplicates!$V$11:$V$15</c:f>
                <c:numCache>
                  <c:formatCode>General</c:formatCode>
                  <c:ptCount val="5"/>
                  <c:pt idx="0">
                    <c:v>2.70149001565003E-2</c:v>
                  </c:pt>
                  <c:pt idx="1">
                    <c:v>1.0295343266591201E-2</c:v>
                  </c:pt>
                  <c:pt idx="2">
                    <c:v>3.3355200056113497E-2</c:v>
                  </c:pt>
                  <c:pt idx="3">
                    <c:v>8.5726565219537101E-2</c:v>
                  </c:pt>
                  <c:pt idx="4">
                    <c:v>0.42468112066407399</c:v>
                  </c:pt>
                </c:numCache>
              </c:numRef>
            </c:plus>
            <c:minus>
              <c:numRef>
                <c:f>triplicates!$V$11:$V$15</c:f>
                <c:numCache>
                  <c:formatCode>General</c:formatCode>
                  <c:ptCount val="5"/>
                  <c:pt idx="0">
                    <c:v>2.70149001565003E-2</c:v>
                  </c:pt>
                  <c:pt idx="1">
                    <c:v>1.0295343266591201E-2</c:v>
                  </c:pt>
                  <c:pt idx="2">
                    <c:v>3.3355200056113497E-2</c:v>
                  </c:pt>
                  <c:pt idx="3">
                    <c:v>8.5726565219537101E-2</c:v>
                  </c:pt>
                  <c:pt idx="4">
                    <c:v>0.424681120664073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riplicates!$M$3:$M$7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54</c:v>
                </c:pt>
                <c:pt idx="4">
                  <c:v>72</c:v>
                </c:pt>
              </c:numCache>
            </c:numRef>
          </c:cat>
          <c:val>
            <c:numRef>
              <c:f>triplicates!$V$3:$V$7</c:f>
              <c:numCache>
                <c:formatCode>General</c:formatCode>
                <c:ptCount val="5"/>
                <c:pt idx="0">
                  <c:v>5.1020337127063149</c:v>
                </c:pt>
                <c:pt idx="1">
                  <c:v>5.6486538812752549</c:v>
                </c:pt>
                <c:pt idx="2">
                  <c:v>6.6823760772766869</c:v>
                </c:pt>
                <c:pt idx="3">
                  <c:v>6.1665054081041966</c:v>
                </c:pt>
                <c:pt idx="4">
                  <c:v>4.87681124582073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9FB-4FD9-A359-3B71D8CDC2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6178184"/>
        <c:axId val="329920272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triplicates!$M$2</c15:sqref>
                        </c15:formulaRef>
                      </c:ext>
                    </c:extLst>
                    <c:strCache>
                      <c:ptCount val="1"/>
                      <c:pt idx="0">
                        <c:v>log10 CFU/ml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val>
                <c:smooth val="0"/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5-79FB-4FD9-A359-3B71D8CDC24C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O$2</c15:sqref>
                        </c15:formulaRef>
                      </c:ext>
                    </c:extLst>
                    <c:strCache>
                      <c:ptCount val="1"/>
                      <c:pt idx="0">
                        <c:v>MEM-Earle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O$3:$O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4074693254472299</c:v>
                      </c:pt>
                      <c:pt idx="1">
                        <c:v>5.5346693088742001</c:v>
                      </c:pt>
                      <c:pt idx="2">
                        <c:v>5.2986228050477058</c:v>
                      </c:pt>
                      <c:pt idx="3">
                        <c:v>3.857054616409163</c:v>
                      </c:pt>
                      <c:pt idx="4">
                        <c:v>2.8689127880633829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6-79FB-4FD9-A359-3B71D8CDC24C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Q$2</c15:sqref>
                        </c15:formulaRef>
                      </c:ext>
                    </c:extLst>
                    <c:strCache>
                      <c:ptCount val="1"/>
                      <c:pt idx="0">
                        <c:v>48 hours spent medium Bomac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Q$3:$Q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8848339283598676</c:v>
                      </c:pt>
                      <c:pt idx="1">
                        <c:v>6.4745517681194356</c:v>
                      </c:pt>
                      <c:pt idx="2">
                        <c:v>6.3949097483544657</c:v>
                      </c:pt>
                      <c:pt idx="3">
                        <c:v>5.4249547945783316</c:v>
                      </c:pt>
                      <c:pt idx="4">
                        <c:v>4.721585937968424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7-79FB-4FD9-A359-3B71D8CDC24C}"/>
                  </c:ext>
                </c:extLst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S$2</c15:sqref>
                        </c15:formulaRef>
                      </c:ext>
                    </c:extLst>
                    <c:strCache>
                      <c:ptCount val="1"/>
                      <c:pt idx="0">
                        <c:v>24 hours spent medium Bomac</c:v>
                      </c:pt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>
                        <a:lumMod val="60000"/>
                      </a:schemeClr>
                    </a:solidFill>
                    <a:ln w="9525">
                      <a:solidFill>
                        <a:schemeClr val="accent1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S$3:$S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7419540811373322</c:v>
                      </c:pt>
                      <c:pt idx="1">
                        <c:v>6.6270596597513753</c:v>
                      </c:pt>
                      <c:pt idx="2">
                        <c:v>6.6887990914304369</c:v>
                      </c:pt>
                      <c:pt idx="3">
                        <c:v>5.717245938488678</c:v>
                      </c:pt>
                      <c:pt idx="4">
                        <c:v>4.9047347387069786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8-79FB-4FD9-A359-3B71D8CDC24C}"/>
                  </c:ext>
                </c:extLst>
              </c15:ser>
            </c15:filteredLineSeries>
            <c15:filteredLineSeries>
              <c15:ser>
                <c:idx val="8"/>
                <c:order val="8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U$2</c15:sqref>
                        </c15:formulaRef>
                      </c:ext>
                    </c:extLst>
                    <c:strCache>
                      <c:ptCount val="1"/>
                      <c:pt idx="0">
                        <c:v>48 hours spent medium Bomac + BVDV</c:v>
                      </c:pt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>
                        <a:lumMod val="60000"/>
                      </a:schemeClr>
                    </a:solidFill>
                    <a:ln w="9525">
                      <a:solidFill>
                        <a:schemeClr val="accent3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U$3:$U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6836727273812437</c:v>
                      </c:pt>
                      <c:pt idx="1">
                        <c:v>6.5766506367468809</c:v>
                      </c:pt>
                      <c:pt idx="2">
                        <c:v>6.5948403876304464</c:v>
                      </c:pt>
                      <c:pt idx="3">
                        <c:v>5.6913342676407757</c:v>
                      </c:pt>
                      <c:pt idx="4">
                        <c:v>4.90900937579356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9-79FB-4FD9-A359-3B71D8CDC24C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W$2</c15:sqref>
                        </c15:formulaRef>
                      </c:ext>
                    </c:extLst>
                    <c:strCache>
                      <c:ptCount val="1"/>
                      <c:pt idx="0">
                        <c:v>24 hours spent medium Bomac + BVDV</c:v>
                      </c:pt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>
                        <a:lumMod val="60000"/>
                      </a:schemeClr>
                    </a:solidFill>
                    <a:ln w="9525">
                      <a:solidFill>
                        <a:schemeClr val="accent5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M$3:$M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6</c:v>
                      </c:pt>
                      <c:pt idx="2">
                        <c:v>24</c:v>
                      </c:pt>
                      <c:pt idx="3">
                        <c:v>54</c:v>
                      </c:pt>
                      <c:pt idx="4">
                        <c:v>72</c:v>
                      </c:pt>
                    </c:numCache>
                  </c:numRef>
                </c:cat>
                <c:val>
                  <c:numRef>
                    <c:extLst xmlns:c15="http://schemas.microsoft.com/office/drawing/2012/chart" xmlns:c16r2="http://schemas.microsoft.com/office/drawing/2015/06/chart">
                      <c:ext xmlns:c15="http://schemas.microsoft.com/office/drawing/2012/chart" uri="{02D57815-91ED-43cb-92C2-25804820EDAC}">
                        <c15:formulaRef>
                          <c15:sqref>triplicates!$W$3:$W$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5.8117053773847456</c:v>
                      </c:pt>
                      <c:pt idx="1">
                        <c:v>6.5811089987045319</c:v>
                      </c:pt>
                      <c:pt idx="2">
                        <c:v>6.5972111441367884</c:v>
                      </c:pt>
                      <c:pt idx="3">
                        <c:v>5.645416371387836</c:v>
                      </c:pt>
                      <c:pt idx="4">
                        <c:v>4.8121784453918224</c:v>
                      </c:pt>
                    </c:numCache>
                  </c:numRef>
                </c:val>
                <c:smooth val="0"/>
                <c:extLst xmlns:c15="http://schemas.microsoft.com/office/drawing/2012/chart" xmlns:c16r2="http://schemas.microsoft.com/office/drawing/2015/06/chart">
                  <c:ext xmlns:c16="http://schemas.microsoft.com/office/drawing/2014/chart" uri="{C3380CC4-5D6E-409C-BE32-E72D297353CC}">
                    <c16:uniqueId val="{0000000A-79FB-4FD9-A359-3B71D8CDC24C}"/>
                  </c:ext>
                </c:extLst>
              </c15:ser>
            </c15:filteredLineSeries>
          </c:ext>
        </c:extLst>
      </c:lineChart>
      <c:dateAx>
        <c:axId val="3061781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sz="14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e </a:t>
                </a: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hour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329920272"/>
        <c:crossesAt val="0"/>
        <c:auto val="0"/>
        <c:lblOffset val="100"/>
        <c:baseTimeUnit val="days"/>
        <c:majorUnit val="6"/>
        <c:majorTimeUnit val="days"/>
      </c:dateAx>
      <c:valAx>
        <c:axId val="329920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10 </a:t>
                </a:r>
                <a:r>
                  <a:rPr lang="en-US" sz="14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FU/mL)</a:t>
                </a:r>
                <a:endParaRPr 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0185185185185199E-3"/>
              <c:y val="0.3454843537414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3061781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62719198790627"/>
          <c:y val="0.19981723356009101"/>
          <c:w val="0.23315608465608501"/>
          <c:h val="0.616520493685026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15774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1290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1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98210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6643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3866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62100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65926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72144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92669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95144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01E8F-1013-4E2D-8FB4-AA9E40A5791D}" type="datetimeFigureOut">
              <a:rPr lang="de-CH" smtClean="0"/>
              <a:t>18.12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8624-11E1-4E7F-9DB6-B77EAE90CCD0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77255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6465043"/>
              </p:ext>
            </p:extLst>
          </p:nvPr>
        </p:nvGraphicFramePr>
        <p:xfrm>
          <a:off x="611560" y="1196752"/>
          <a:ext cx="7938000" cy="44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93490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8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Company>VETSUISS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i, Christoph (VETSUISSE)</dc:creator>
  <cp:lastModifiedBy>ecoulamy</cp:lastModifiedBy>
  <cp:revision>14</cp:revision>
  <cp:lastPrinted>2017-11-06T14:50:12Z</cp:lastPrinted>
  <dcterms:created xsi:type="dcterms:W3CDTF">2017-11-06T10:40:48Z</dcterms:created>
  <dcterms:modified xsi:type="dcterms:W3CDTF">2017-12-18T14:03:41Z</dcterms:modified>
</cp:coreProperties>
</file>